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Default Extension="pdf" ContentType="application/pdf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 varScale="1">
        <p:scale>
          <a:sx n="75" d="100"/>
          <a:sy n="75" d="100"/>
        </p:scale>
        <p:origin x="-2392" y="-10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A397A-25D2-F849-8869-BE54055D3E63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9A233-18E4-FC44-B3DF-68BD8EEF851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A397A-25D2-F849-8869-BE54055D3E63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9A233-18E4-FC44-B3DF-68BD8EEF851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A397A-25D2-F849-8869-BE54055D3E63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9A233-18E4-FC44-B3DF-68BD8EEF851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A397A-25D2-F849-8869-BE54055D3E63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9A233-18E4-FC44-B3DF-68BD8EEF851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A397A-25D2-F849-8869-BE54055D3E63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9A233-18E4-FC44-B3DF-68BD8EEF851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A397A-25D2-F849-8869-BE54055D3E63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9A233-18E4-FC44-B3DF-68BD8EEF851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A397A-25D2-F849-8869-BE54055D3E63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9A233-18E4-FC44-B3DF-68BD8EEF851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A397A-25D2-F849-8869-BE54055D3E63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9A233-18E4-FC44-B3DF-68BD8EEF851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A397A-25D2-F849-8869-BE54055D3E63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9A233-18E4-FC44-B3DF-68BD8EEF851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A397A-25D2-F849-8869-BE54055D3E63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9A233-18E4-FC44-B3DF-68BD8EEF851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A397A-25D2-F849-8869-BE54055D3E63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9A233-18E4-FC44-B3DF-68BD8EEF851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3A397A-25D2-F849-8869-BE54055D3E63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9A233-18E4-FC44-B3DF-68BD8EEF851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df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d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emaleleptforest.pdf"/>
          <p:cNvPicPr>
            <a:picLocks noChangeAspect="1"/>
          </p:cNvPicPr>
          <p:nvPr/>
        </p:nvPicPr>
        <mc:AlternateContent>
          <mc:Choice xmlns:ma="http://schemas.microsoft.com/office/mac/drawingml/2008/main" Requires="ma">
            <p:blipFill>
              <a:blip r:embed="rId2"/>
              <a:stretch>
                <a:fillRect/>
              </a:stretch>
            </p:blipFill>
          </mc:Choice>
          <mc:Fallback>
            <p:blipFill>
              <a:blip r:embed="rId3"/>
              <a:stretch>
                <a:fillRect/>
              </a:stretch>
            </p:blipFill>
          </mc:Fallback>
        </mc:AlternateContent>
        <p:spPr>
          <a:xfrm>
            <a:off x="3422572" y="3534797"/>
            <a:ext cx="3200400" cy="3200400"/>
          </a:xfrm>
          <a:prstGeom prst="rect">
            <a:avLst/>
          </a:prstGeom>
        </p:spPr>
      </p:pic>
      <p:pic>
        <p:nvPicPr>
          <p:cNvPr id="5" name="Picture 4" descr="maleleptforest.pdf"/>
          <p:cNvPicPr>
            <a:picLocks noChangeAspect="1"/>
          </p:cNvPicPr>
          <p:nvPr/>
        </p:nvPicPr>
        <mc:AlternateContent>
          <mc:Choice xmlns:ma="http://schemas.microsoft.com/office/mac/drawingml/2008/main" Requires="ma">
            <p:blipFill>
              <a:blip r:embed="rId4"/>
              <a:stretch>
                <a:fillRect/>
              </a:stretch>
            </p:blipFill>
          </mc:Choice>
          <mc:Fallback>
            <p:blipFill>
              <a:blip r:embed="rId5"/>
              <a:stretch>
                <a:fillRect/>
              </a:stretch>
            </p:blipFill>
          </mc:Fallback>
        </mc:AlternateContent>
        <p:spPr>
          <a:xfrm>
            <a:off x="222172" y="3534797"/>
            <a:ext cx="3200400" cy="32004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83042" y="3534797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422572" y="3534797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39564" y="309372"/>
            <a:ext cx="5825769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igure S4: Forest plots for male and female</a:t>
            </a:r>
            <a:r>
              <a:rPr lang="en-US" sz="1200" dirty="0" smtClean="0"/>
              <a:t> </a:t>
            </a:r>
            <a:r>
              <a:rPr lang="en-US" sz="1200" dirty="0" err="1" smtClean="0"/>
              <a:t>l</a:t>
            </a:r>
            <a:r>
              <a:rPr lang="en-US" sz="1200" smtClean="0"/>
              <a:t>eptin</a:t>
            </a:r>
            <a:r>
              <a:rPr lang="en-US" sz="1200" dirty="0" smtClean="0"/>
              <a:t>. (a) Male offspring, (</a:t>
            </a:r>
            <a:r>
              <a:rPr lang="en-US" sz="1200" dirty="0" err="1" smtClean="0"/>
              <a:t>b</a:t>
            </a:r>
            <a:r>
              <a:rPr lang="en-US" sz="1200" dirty="0" smtClean="0"/>
              <a:t>) female offspring</a:t>
            </a:r>
            <a:r>
              <a:rPr lang="en-GB" sz="1200" dirty="0" smtClean="0"/>
              <a:t>. </a:t>
            </a:r>
            <a:r>
              <a:rPr lang="en-GB" sz="1200" dirty="0" smtClean="0"/>
              <a:t>In the TOTAL model, estimated SMD and 95% confidence intervals are presented as a summary of all studies. </a:t>
            </a:r>
            <a:r>
              <a:rPr lang="en-GB" sz="1200" dirty="0" err="1" smtClean="0"/>
              <a:t>k</a:t>
            </a:r>
            <a:r>
              <a:rPr lang="en-GB" sz="1200" dirty="0" smtClean="0"/>
              <a:t> refers to the number of studies included. The significance of the effect size was assessed by random-effects model analysis. Explanation for heterogeneity was explored by meta-regression by including various moderating factors into the random-effects model.</a:t>
            </a:r>
            <a:r>
              <a:rPr lang="en-GB" sz="1200" b="1" dirty="0" smtClean="0"/>
              <a:t> </a:t>
            </a:r>
            <a:r>
              <a:rPr lang="en-GB" sz="1200" dirty="0" smtClean="0"/>
              <a:t>These included: </a:t>
            </a:r>
            <a:r>
              <a:rPr lang="en-GB" sz="1200" i="1" dirty="0" smtClean="0"/>
              <a:t>Nesting </a:t>
            </a:r>
            <a:r>
              <a:rPr lang="en-GB" sz="1200" dirty="0" smtClean="0"/>
              <a:t>- the use of statistical procedures to account for non-independence of animals from the same litter; </a:t>
            </a:r>
            <a:r>
              <a:rPr lang="en-GB" sz="1200" i="1" dirty="0" smtClean="0"/>
              <a:t>Randomisation </a:t>
            </a:r>
            <a:r>
              <a:rPr lang="en-GB" sz="1200" dirty="0" smtClean="0"/>
              <a:t>- the random assignment of animals to each intervention group; </a:t>
            </a:r>
            <a:r>
              <a:rPr lang="en-GB" sz="1200" i="1" dirty="0" smtClean="0"/>
              <a:t>CD:HFD ratio</a:t>
            </a:r>
            <a:r>
              <a:rPr lang="en-GB" sz="1200" dirty="0" smtClean="0"/>
              <a:t> of macronutrients, fat, Carbohydrate (CHO) and Protein, </a:t>
            </a:r>
            <a:r>
              <a:rPr lang="en-GB" sz="1200" i="1" dirty="0" smtClean="0"/>
              <a:t>Cafeteria diet</a:t>
            </a:r>
            <a:r>
              <a:rPr lang="en-GB" sz="1200" dirty="0" smtClean="0"/>
              <a:t> - the use of choice diet or supplementation of standard diets with palatable energy-rich foods, </a:t>
            </a:r>
            <a:r>
              <a:rPr lang="en-GB" sz="1200" i="1" dirty="0" smtClean="0"/>
              <a:t>species</a:t>
            </a:r>
            <a:r>
              <a:rPr lang="en-GB" sz="1200" dirty="0" smtClean="0"/>
              <a:t>, </a:t>
            </a:r>
            <a:r>
              <a:rPr lang="en-GB" sz="1200" i="1" dirty="0" smtClean="0"/>
              <a:t>maternal weight </a:t>
            </a:r>
            <a:r>
              <a:rPr lang="en-GB" sz="1200" dirty="0" smtClean="0"/>
              <a:t>- an approximation for gestation weight gain taken as the ratio change in weight from pre mating to post lactation. Estimates for the SMD and 95% confidence intervals are presented for these models along with the residual heterogeneity unaccounted for in the model (the I^2 beneath each model). </a:t>
            </a:r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19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homas Chambers</dc:creator>
  <cp:lastModifiedBy>Thomas Chambers</cp:lastModifiedBy>
  <cp:revision>3</cp:revision>
  <dcterms:created xsi:type="dcterms:W3CDTF">2016-09-23T12:24:50Z</dcterms:created>
  <dcterms:modified xsi:type="dcterms:W3CDTF">2016-09-23T12:29:57Z</dcterms:modified>
</cp:coreProperties>
</file>